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89995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12B13-4A25-4605-9DC3-6D88134C8B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612144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9640" y="5421240"/>
            <a:ext cx="612144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16C6E-F60E-4012-9E5B-1A417778A6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964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7632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31CBF-091A-4DEF-8BE7-FCDADCD503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09640" y="260028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679640" y="260028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9640" y="542124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09640" y="542124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679640" y="542124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0BDB8-05C5-49D1-B50E-FDF7051DDD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9640" y="2600280"/>
            <a:ext cx="6121440" cy="540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7733A-6CB2-4F88-A531-7DF4E5FC00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612144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C2C40-AFBC-486F-9A51-A3C3600734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87394-F806-4570-A6CE-9C2055F5FA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A5D61-A8E0-4F91-9E19-9540B9DC46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9640" y="799920"/>
            <a:ext cx="6121440" cy="695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DEA7D-B0D5-48B9-B263-F04070DDC8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964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6B770-A72E-4796-8ABF-F935260992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7632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6862C6-3989-43BE-A416-68438C6CCD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9640" y="5421240"/>
            <a:ext cx="612144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C1F32-6E0D-4A1A-B5A2-FCA7CC18C4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9640" y="2600280"/>
            <a:ext cx="612144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marL="347760" indent="-347760">
              <a:spcBef>
                <a:spcPts val="825"/>
              </a:spcBef>
              <a:buClr>
                <a:srgbClr val="000000"/>
              </a:buClr>
              <a:buFont typeface="Times New Roman"/>
              <a:buChar char="•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1" marL="752400" indent="-288720">
              <a:spcBef>
                <a:spcPts val="825"/>
              </a:spcBef>
              <a:buClr>
                <a:srgbClr val="000000"/>
              </a:buClr>
              <a:buFont typeface="Times New Roman"/>
              <a:buChar char="–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2" marL="1157400" indent="-231840">
              <a:spcBef>
                <a:spcPts val="825"/>
              </a:spcBef>
              <a:buClr>
                <a:srgbClr val="000000"/>
              </a:buClr>
              <a:buFont typeface="Times New Roman"/>
              <a:buChar char="•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3" marL="1620720" indent="-231480">
              <a:spcBef>
                <a:spcPts val="825"/>
              </a:spcBef>
              <a:buClr>
                <a:srgbClr val="000000"/>
              </a:buClr>
              <a:buFont typeface="Times New Roman"/>
              <a:buChar char="–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4" marL="2082960" indent="-230400">
              <a:spcBef>
                <a:spcPts val="825"/>
              </a:spcBef>
              <a:buClr>
                <a:srgbClr val="000000"/>
              </a:buClr>
              <a:buFont typeface="Times New Roman"/>
              <a:buChar char="»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5" marL="2082960" indent="-230400">
              <a:spcBef>
                <a:spcPts val="825"/>
              </a:spcBef>
              <a:buClr>
                <a:srgbClr val="000000"/>
              </a:buClr>
              <a:buFont typeface="Times New Roman"/>
              <a:buChar char="»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6" marL="2082960" indent="-230400">
              <a:spcBef>
                <a:spcPts val="825"/>
              </a:spcBef>
              <a:buClr>
                <a:srgbClr val="000000"/>
              </a:buClr>
              <a:buFont typeface="Times New Roman"/>
              <a:buChar char="»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8200800"/>
            <a:ext cx="1500120" cy="6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lstStyle>
            <a:lvl1pPr indent="0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8200800"/>
            <a:ext cx="2279520" cy="6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lstStyle>
            <a:lvl1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8200800"/>
            <a:ext cx="1500120" cy="6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fld id="{3B4F070C-2A56-4815-B9E0-3891931419DF}" type="slidenum"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3.png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033640" y="307800"/>
          <a:ext cx="4914720" cy="16369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33640" y="307800"/>
                    <a:ext cx="4914720" cy="1636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557360" y="125280"/>
            <a:ext cx="5029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-1389240" y="4118400"/>
            <a:ext cx="43927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3000" spc="-1" strike="noStrike">
                <a:solidFill>
                  <a:srgbClr val="000000"/>
                </a:solidFill>
                <a:latin typeface="Arial"/>
              </a:rPr>
              <a:t>Secondary Metabolites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2038320" y="2077920"/>
          <a:ext cx="4915080" cy="16671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038320" y="2077920"/>
                    <a:ext cx="4915080" cy="1667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2038320" y="3913200"/>
          <a:ext cx="4923000" cy="18111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038320" y="3913200"/>
                    <a:ext cx="4923000" cy="181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2038320" y="5894280"/>
          <a:ext cx="4946760" cy="220680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038320" y="5894280"/>
                    <a:ext cx="4946760" cy="2206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"/>
          <p:cNvSpPr/>
          <p:nvPr/>
        </p:nvSpPr>
        <p:spPr>
          <a:xfrm>
            <a:off x="1584360" y="1938240"/>
            <a:ext cx="5029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584360" y="3745080"/>
            <a:ext cx="5029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549440" y="5716440"/>
            <a:ext cx="56520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776600" y="3529080"/>
            <a:ext cx="312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776600" y="1722600"/>
            <a:ext cx="312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765440" y="5502240"/>
            <a:ext cx="312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776600" y="7518240"/>
            <a:ext cx="312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292320" y="6555600"/>
            <a:ext cx="230508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440" bIns="464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(peak area per mg leaf fresh mass)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051280" y="176040"/>
            <a:ext cx="4615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051280" y="1944720"/>
            <a:ext cx="4615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051280" y="3800520"/>
            <a:ext cx="4615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2051280" y="5781600"/>
            <a:ext cx="4615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1584360" y="181080"/>
            <a:ext cx="6480" cy="554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3760560" y="219240"/>
            <a:ext cx="1529280" cy="412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Anabasin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3195000" y="2036880"/>
            <a:ext cx="2614320" cy="412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Caffeoylputrescin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3244320" y="3844800"/>
            <a:ext cx="2358360" cy="412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Chlorogenic acid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033440" y="5826240"/>
            <a:ext cx="802440" cy="412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Ruti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044800" y="776124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441520" y="775800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2859120" y="775800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301480" y="8104320"/>
            <a:ext cx="75672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5799600" y="8104320"/>
            <a:ext cx="100512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MeJA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268800" y="776124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3657600" y="775800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095720" y="775800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491000" y="776124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889520" y="775800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5303880" y="775800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5695920" y="776124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6111720" y="775800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6553440" y="775800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3689640" y="8104320"/>
            <a:ext cx="41508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610880" y="8104320"/>
            <a:ext cx="86184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W+R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 rot="16200000">
            <a:off x="-308160" y="2606760"/>
            <a:ext cx="320364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440" bIns="464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(µg per mg leaf fresh mass)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10-24T07:45:31Z</dcterms:created>
  <dc:creator>Anke Steppuhn</dc:creator>
  <dc:description/>
  <dc:language>en-US</dc:language>
  <cp:lastModifiedBy>Anke Steppuhn</cp:lastModifiedBy>
  <dcterms:modified xsi:type="dcterms:W3CDTF">2004-05-01T11:23:43Z</dcterms:modified>
  <cp:revision>14</cp:revision>
  <dc:subject/>
  <dc:title>PowerPoint-Präsentation</dc:title>
</cp:coreProperties>
</file>